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320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447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585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75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34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298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631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339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183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533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997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443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900657" y="0"/>
            <a:ext cx="8201476" cy="5068984"/>
            <a:chOff x="222551" y="1461377"/>
            <a:chExt cx="8201476" cy="5068984"/>
          </a:xfrm>
        </p:grpSpPr>
        <p:pic>
          <p:nvPicPr>
            <p:cNvPr id="12" name="Picture 5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5" r="48121" b="52739"/>
            <a:stretch/>
          </p:blipFill>
          <p:spPr bwMode="auto">
            <a:xfrm>
              <a:off x="5856203" y="4140697"/>
              <a:ext cx="2448272" cy="22391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" name="Picture 8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6" t="3896"/>
            <a:stretch/>
          </p:blipFill>
          <p:spPr bwMode="auto">
            <a:xfrm>
              <a:off x="222551" y="1461377"/>
              <a:ext cx="5602657" cy="25605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83" t="5553" r="3565" b="3274"/>
            <a:stretch/>
          </p:blipFill>
          <p:spPr bwMode="auto">
            <a:xfrm>
              <a:off x="296089" y="4053666"/>
              <a:ext cx="5352227" cy="24766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1" t="5555" r="67003" b="2976"/>
            <a:stretch/>
          </p:blipFill>
          <p:spPr bwMode="auto">
            <a:xfrm>
              <a:off x="5648315" y="1484624"/>
              <a:ext cx="2775712" cy="25469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" name="Rectangle 12"/>
            <p:cNvSpPr/>
            <p:nvPr/>
          </p:nvSpPr>
          <p:spPr>
            <a:xfrm>
              <a:off x="7249469" y="4313121"/>
              <a:ext cx="982999" cy="1017638"/>
            </a:xfrm>
            <a:prstGeom prst="rect">
              <a:avLst/>
            </a:prstGeom>
            <a:noFill/>
            <a:ln w="444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6254343" y="5328038"/>
              <a:ext cx="987552" cy="679368"/>
            </a:xfrm>
            <a:prstGeom prst="rect">
              <a:avLst/>
            </a:prstGeom>
            <a:noFill/>
            <a:ln w="444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7296364" y="2037442"/>
              <a:ext cx="100748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>
                  <a:solidFill>
                    <a:srgbClr val="00B050"/>
                  </a:solidFill>
                </a:rPr>
                <a:t>MSC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7280745" y="4274551"/>
              <a:ext cx="92044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Hi-</a:t>
              </a:r>
              <a:r>
                <a:rPr lang="en-US" sz="2400" dirty="0" err="1"/>
                <a:t>mt</a:t>
              </a:r>
              <a:endParaRPr lang="en-US" sz="24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235293" y="5618792"/>
              <a:ext cx="91595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Lo-</a:t>
              </a:r>
              <a:r>
                <a:rPr lang="en-US" sz="2400" dirty="0" err="1"/>
                <a:t>mt</a:t>
              </a:r>
              <a:endParaRPr lang="en-US" sz="2400" dirty="0"/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2391752" y="5043090"/>
            <a:ext cx="820614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Figure 5. Gating strategy for mitochondrial parameters and Anti-oxidant status in CD105+ MSCs</a:t>
            </a:r>
            <a:r>
              <a:rPr lang="en-US" dirty="0" smtClean="0"/>
              <a:t>. MSCs </a:t>
            </a:r>
            <a:r>
              <a:rPr lang="en-US" smtClean="0"/>
              <a:t>= mesenchymal </a:t>
            </a:r>
            <a:r>
              <a:rPr lang="en-US"/>
              <a:t>s</a:t>
            </a:r>
            <a:r>
              <a:rPr lang="en-US" smtClean="0"/>
              <a:t>tem </a:t>
            </a:r>
            <a:r>
              <a:rPr lang="en-US" dirty="0"/>
              <a:t>c</a:t>
            </a:r>
            <a:r>
              <a:rPr lang="en-US" smtClean="0"/>
              <a:t>ells</a:t>
            </a:r>
            <a:r>
              <a:rPr lang="en-US" dirty="0" smtClean="0"/>
              <a:t>, GSH = glutathione, FSC = forward scatter, SSC= </a:t>
            </a:r>
            <a:r>
              <a:rPr lang="en-US" smtClean="0"/>
              <a:t>side scatter.</a:t>
            </a:r>
            <a:endParaRPr lang="en-US" dirty="0"/>
          </a:p>
        </p:txBody>
      </p:sp>
      <p:sp>
        <p:nvSpPr>
          <p:cNvPr id="21" name="Right Arrow 20"/>
          <p:cNvSpPr/>
          <p:nvPr/>
        </p:nvSpPr>
        <p:spPr>
          <a:xfrm>
            <a:off x="4617671" y="1395718"/>
            <a:ext cx="323543" cy="310896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ight Arrow 21"/>
          <p:cNvSpPr/>
          <p:nvPr/>
        </p:nvSpPr>
        <p:spPr>
          <a:xfrm>
            <a:off x="7326421" y="1395718"/>
            <a:ext cx="323543" cy="310896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8261693" y="3274839"/>
            <a:ext cx="452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23%</a:t>
            </a:r>
            <a:endParaRPr lang="en-US" sz="12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9192781" y="3295111"/>
            <a:ext cx="452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27%</a:t>
            </a:r>
            <a:endParaRPr lang="en-US" sz="12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9127888" y="3879518"/>
            <a:ext cx="452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19%</a:t>
            </a:r>
            <a:endParaRPr lang="en-US" sz="12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8244912" y="3988820"/>
            <a:ext cx="452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31%</a:t>
            </a:r>
            <a:endParaRPr lang="en-US" sz="12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8034907" y="649368"/>
            <a:ext cx="9395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98.8%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3815953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3</TotalTime>
  <Words>50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Ternan, Patrick</dc:creator>
  <cp:lastModifiedBy>McTernan, Patrick</cp:lastModifiedBy>
  <cp:revision>11</cp:revision>
  <dcterms:created xsi:type="dcterms:W3CDTF">2020-05-21T15:38:18Z</dcterms:created>
  <dcterms:modified xsi:type="dcterms:W3CDTF">2020-11-13T22:46:03Z</dcterms:modified>
</cp:coreProperties>
</file>